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739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4C0AEF0-DE69-E467-EB5D-1680687FE0F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559DF16B-8023-ED30-13BF-7D75AB281AD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A07781A-CDC3-5FEB-8118-99C1D0D357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124CE-C51E-4B8E-BBB1-833822312B51}" type="datetimeFigureOut">
              <a:rPr kumimoji="1" lang="ja-JP" altLang="en-US" smtClean="0"/>
              <a:t>2024/8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E3C4DDE-1036-6B84-A004-BE1273BE4B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8D3500A-93C4-6111-291A-5F23EEFDBE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DAC89-E625-4CC8-8EDE-D27F3EA506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55566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B03DEF5-D8D6-95BD-AF48-9F026D08F0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6DEBAC2-A192-B81C-FBA8-01D05C356A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104FEB3-B450-0EDF-7407-2E582BBC45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124CE-C51E-4B8E-BBB1-833822312B51}" type="datetimeFigureOut">
              <a:rPr kumimoji="1" lang="ja-JP" altLang="en-US" smtClean="0"/>
              <a:t>2024/8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25C9E09-67DF-C398-29E2-931B64F49E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59AD6D0-72F6-E727-50B6-210C860830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DAC89-E625-4CC8-8EDE-D27F3EA506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66563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2513F539-26FE-C723-2F80-C29DC39861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355286E-26A5-34FC-DF70-789D4B1F36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6D3D86C-5301-50C6-CE7A-B8A2CA375C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124CE-C51E-4B8E-BBB1-833822312B51}" type="datetimeFigureOut">
              <a:rPr kumimoji="1" lang="ja-JP" altLang="en-US" smtClean="0"/>
              <a:t>2024/8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C19E2EF-1702-763A-2B1A-5E9113108A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EE6A93B-D696-46D2-0C7B-34EEF2EDD5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DAC89-E625-4CC8-8EDE-D27F3EA506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93337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C3EEF58-6059-4208-6963-F494C43B69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A1763EF-1C58-CF7F-3AA7-5E4BC49836B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54C77E1-300B-64E2-43FA-CE459ACCFB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124CE-C51E-4B8E-BBB1-833822312B51}" type="datetimeFigureOut">
              <a:rPr kumimoji="1" lang="ja-JP" altLang="en-US" smtClean="0"/>
              <a:t>2024/8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9399FD9-80EC-6F65-051A-920DE2C1D3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B378D31-9829-C483-BD79-B83BF88C81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DAC89-E625-4CC8-8EDE-D27F3EA506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6952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EC0D4DA-0335-083B-CF2C-9865077443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F059653-2EA3-FF72-AEE3-B7C1D931B3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D6DC85E-F1C9-9819-EF9A-D2CB30CCDD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124CE-C51E-4B8E-BBB1-833822312B51}" type="datetimeFigureOut">
              <a:rPr kumimoji="1" lang="ja-JP" altLang="en-US" smtClean="0"/>
              <a:t>2024/8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31BB985-5592-5AD1-ADA1-7A9684F53E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387D75E-6885-9971-B38E-15A6C8C3D1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DAC89-E625-4CC8-8EDE-D27F3EA506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0048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633FEB1-287C-B50B-EAC7-C0C7524DB2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C5FC009-375F-8315-8A3F-226D0E830F3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0FAA742-0EF0-C5F4-BD69-C8A0FAFEB0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C326974-36D9-0A9C-94CA-556BE5D6A1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124CE-C51E-4B8E-BBB1-833822312B51}" type="datetimeFigureOut">
              <a:rPr kumimoji="1" lang="ja-JP" altLang="en-US" smtClean="0"/>
              <a:t>2024/8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6269770-FE3F-FBB6-95C0-BAC42377C0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FCD7E5F-822C-3966-BCBF-34DA0D04E7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DAC89-E625-4CC8-8EDE-D27F3EA506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01586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661F536-2A4E-5B25-42E5-0D9547FD75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1F6BC1D-871D-B9F1-27EE-EC4C61EA4B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A1D4336-8D4A-3D7B-A262-987AD23DB0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FF4636F-D028-415C-E469-9FF1E508152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1863C641-3139-42F1-226B-13EAA1C2AF3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A4D2B01-5A66-B0B2-841E-845B1285A3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124CE-C51E-4B8E-BBB1-833822312B51}" type="datetimeFigureOut">
              <a:rPr kumimoji="1" lang="ja-JP" altLang="en-US" smtClean="0"/>
              <a:t>2024/8/3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FA295C0-CA08-A682-B1A3-5CD25AD85C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BB08D10-BFE2-4FAA-7311-D8376A48A3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DAC89-E625-4CC8-8EDE-D27F3EA506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15403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C8C2995-EF2E-602E-13AB-FDF9F1C656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378E96D-C424-0BDA-7087-B351543842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124CE-C51E-4B8E-BBB1-833822312B51}" type="datetimeFigureOut">
              <a:rPr kumimoji="1" lang="ja-JP" altLang="en-US" smtClean="0"/>
              <a:t>2024/8/3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E8A7DB7A-7CB5-865E-13E6-53F8EFA7C8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E1BE99B-B257-88DC-CF07-70975099A0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DAC89-E625-4CC8-8EDE-D27F3EA506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37213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EAA8803F-434B-15DE-AE3E-E25665FF9E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124CE-C51E-4B8E-BBB1-833822312B51}" type="datetimeFigureOut">
              <a:rPr kumimoji="1" lang="ja-JP" altLang="en-US" smtClean="0"/>
              <a:t>2024/8/3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4378A0E-5987-1026-72B5-0827288C3A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D35DB1F-CA1E-7BE4-E6C2-55C87D0F57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DAC89-E625-4CC8-8EDE-D27F3EA506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10766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9AA3421-89D9-B0B7-24E5-3CC0C1AF49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F59C051-D623-A1D3-ADF3-86C47C62834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2D3D291-032A-2FE6-B1A5-237400DFD7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E9DFBF6-4D1A-6C26-B99D-59A4F0D258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124CE-C51E-4B8E-BBB1-833822312B51}" type="datetimeFigureOut">
              <a:rPr kumimoji="1" lang="ja-JP" altLang="en-US" smtClean="0"/>
              <a:t>2024/8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E21BC9B-92FE-DCB3-3FFD-5090AEDDC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8945CD9-6F4F-7B9C-B162-FAB149BFC6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DAC89-E625-4CC8-8EDE-D27F3EA506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13469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1E9BAB6-11EF-D9C8-B9AD-0EAB10EB29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F60E55D-768A-915A-F0B5-A144B41B297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9B82625-9D5D-34EB-82C5-D827D90CD4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0B13565-1BD9-C807-47A5-FCC0F9252D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124CE-C51E-4B8E-BBB1-833822312B51}" type="datetimeFigureOut">
              <a:rPr kumimoji="1" lang="ja-JP" altLang="en-US" smtClean="0"/>
              <a:t>2024/8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F71978B-DB4B-5CD2-4B8A-CDD65DAD66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4C4488F-3D24-CE2B-65D5-255136F619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DAC89-E625-4CC8-8EDE-D27F3EA506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03657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10A80833-C090-2DC0-AEBA-2280A8ADEF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019CAFD-91E3-5AEC-82DB-53E5E5479B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A90A576-F729-74E2-223C-C2AD0BE0366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A124CE-C51E-4B8E-BBB1-833822312B51}" type="datetimeFigureOut">
              <a:rPr kumimoji="1" lang="ja-JP" altLang="en-US" smtClean="0"/>
              <a:t>2024/8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EA9A0D4-C9B6-A175-4259-20F9174AE0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A92DA5A-7E2E-65C9-419D-B2622728EB5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2DAC89-E625-4CC8-8EDE-D27F3EA506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17358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4">
            <a:extLst>
              <a:ext uri="{FF2B5EF4-FFF2-40B4-BE49-F238E27FC236}">
                <a16:creationId xmlns:a16="http://schemas.microsoft.com/office/drawing/2014/main" id="{6DF71C86-31BE-5B22-FD18-A217166BCA86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2834622" y="285047"/>
            <a:ext cx="5834032" cy="5680896"/>
            <a:chOff x="1695" y="381"/>
            <a:chExt cx="3924" cy="3821"/>
          </a:xfrm>
        </p:grpSpPr>
        <p:sp>
          <p:nvSpPr>
            <p:cNvPr id="8" name="Rectangle 5">
              <a:extLst>
                <a:ext uri="{FF2B5EF4-FFF2-40B4-BE49-F238E27FC236}">
                  <a16:creationId xmlns:a16="http://schemas.microsoft.com/office/drawing/2014/main" id="{08F2508C-31E4-A64D-E234-72E6F478A5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93" y="4016"/>
              <a:ext cx="760" cy="1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dirty="0">
                  <a:latin typeface="メイリオ" panose="020B0604030504040204" pitchFamily="50" charset="-128"/>
                  <a:ea typeface="メイリオ" panose="020B0604030504040204" pitchFamily="50" charset="-128"/>
                </a:rPr>
                <a:t>Specificity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9" name="Rectangle 6">
              <a:extLst>
                <a:ext uri="{FF2B5EF4-FFF2-40B4-BE49-F238E27FC236}">
                  <a16:creationId xmlns:a16="http://schemas.microsoft.com/office/drawing/2014/main" id="{95C22B00-8B1D-4F2A-1652-C4BFEEF77B4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434" y="1907"/>
              <a:ext cx="688" cy="1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600" dirty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Sensitivity</a:t>
              </a:r>
              <a:endParaRPr kumimoji="0" lang="ja-JP" altLang="ja-JP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" name="Rectangle 7">
              <a:extLst>
                <a:ext uri="{FF2B5EF4-FFF2-40B4-BE49-F238E27FC236}">
                  <a16:creationId xmlns:a16="http://schemas.microsoft.com/office/drawing/2014/main" id="{072C707D-F753-0FE9-6E9A-E8218DA1EB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0" y="381"/>
              <a:ext cx="3329" cy="3329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" name="Line 8">
              <a:extLst>
                <a:ext uri="{FF2B5EF4-FFF2-40B4-BE49-F238E27FC236}">
                  <a16:creationId xmlns:a16="http://schemas.microsoft.com/office/drawing/2014/main" id="{489285D0-7718-4A67-5FF1-B87B958845F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16" y="3710"/>
              <a:ext cx="308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" name="Line 9">
              <a:extLst>
                <a:ext uri="{FF2B5EF4-FFF2-40B4-BE49-F238E27FC236}">
                  <a16:creationId xmlns:a16="http://schemas.microsoft.com/office/drawing/2014/main" id="{0A351B47-6592-1A72-4DDD-C8B0CF5AC77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99" y="3710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" name="Line 10">
              <a:extLst>
                <a:ext uri="{FF2B5EF4-FFF2-40B4-BE49-F238E27FC236}">
                  <a16:creationId xmlns:a16="http://schemas.microsoft.com/office/drawing/2014/main" id="{B7169674-0CEB-664F-D1F2-14870A0606F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80" y="3710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" name="Line 11">
              <a:extLst>
                <a:ext uri="{FF2B5EF4-FFF2-40B4-BE49-F238E27FC236}">
                  <a16:creationId xmlns:a16="http://schemas.microsoft.com/office/drawing/2014/main" id="{33201DAD-E4FD-CD0A-217B-0972F504C3B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61" y="3710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" name="Line 12">
              <a:extLst>
                <a:ext uri="{FF2B5EF4-FFF2-40B4-BE49-F238E27FC236}">
                  <a16:creationId xmlns:a16="http://schemas.microsoft.com/office/drawing/2014/main" id="{705D6EEA-8FF2-56F7-D853-F407E35AF9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48" y="3710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" name="Line 13">
              <a:extLst>
                <a:ext uri="{FF2B5EF4-FFF2-40B4-BE49-F238E27FC236}">
                  <a16:creationId xmlns:a16="http://schemas.microsoft.com/office/drawing/2014/main" id="{D06C49A9-8BA4-54BC-6298-40E7B682F07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29" y="3710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" name="Line 14">
              <a:extLst>
                <a:ext uri="{FF2B5EF4-FFF2-40B4-BE49-F238E27FC236}">
                  <a16:creationId xmlns:a16="http://schemas.microsoft.com/office/drawing/2014/main" id="{B33F7B29-E9F6-8BC0-84D2-DBC8F20C766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16" y="3710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" name="Rectangle 15">
              <a:extLst>
                <a:ext uri="{FF2B5EF4-FFF2-40B4-BE49-F238E27FC236}">
                  <a16:creationId xmlns:a16="http://schemas.microsoft.com/office/drawing/2014/main" id="{DEF5A6A2-5480-149D-FAA1-760841E86D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9" y="3837"/>
              <a:ext cx="166" cy="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1.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9" name="Rectangle 16">
              <a:extLst>
                <a:ext uri="{FF2B5EF4-FFF2-40B4-BE49-F238E27FC236}">
                  <a16:creationId xmlns:a16="http://schemas.microsoft.com/office/drawing/2014/main" id="{B650B213-FDFE-9286-FD82-E4E8A2DFA6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42" y="3837"/>
              <a:ext cx="166" cy="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0.8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20" name="Rectangle 17">
              <a:extLst>
                <a:ext uri="{FF2B5EF4-FFF2-40B4-BE49-F238E27FC236}">
                  <a16:creationId xmlns:a16="http://schemas.microsoft.com/office/drawing/2014/main" id="{4D661BF8-B752-3F9B-26AF-846583C24A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61" y="3837"/>
              <a:ext cx="166" cy="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0.6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21" name="Rectangle 18">
              <a:extLst>
                <a:ext uri="{FF2B5EF4-FFF2-40B4-BE49-F238E27FC236}">
                  <a16:creationId xmlns:a16="http://schemas.microsoft.com/office/drawing/2014/main" id="{39BF9F02-DB4F-70B1-4A60-87FBDBA9DC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74" y="3837"/>
              <a:ext cx="166" cy="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0.4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22" name="Rectangle 19">
              <a:extLst>
                <a:ext uri="{FF2B5EF4-FFF2-40B4-BE49-F238E27FC236}">
                  <a16:creationId xmlns:a16="http://schemas.microsoft.com/office/drawing/2014/main" id="{63098E68-8AD2-AC97-34A6-6656B91430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93" y="3837"/>
              <a:ext cx="166" cy="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0.2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23" name="Rectangle 20">
              <a:extLst>
                <a:ext uri="{FF2B5EF4-FFF2-40B4-BE49-F238E27FC236}">
                  <a16:creationId xmlns:a16="http://schemas.microsoft.com/office/drawing/2014/main" id="{6118F189-30F0-0B54-BD47-1C7E005949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12" y="3837"/>
              <a:ext cx="166" cy="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0.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24" name="Line 21">
              <a:extLst>
                <a:ext uri="{FF2B5EF4-FFF2-40B4-BE49-F238E27FC236}">
                  <a16:creationId xmlns:a16="http://schemas.microsoft.com/office/drawing/2014/main" id="{840C8175-4E98-DA84-77F1-867C0800FD9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90" y="502"/>
              <a:ext cx="0" cy="308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" name="Line 22">
              <a:extLst>
                <a:ext uri="{FF2B5EF4-FFF2-40B4-BE49-F238E27FC236}">
                  <a16:creationId xmlns:a16="http://schemas.microsoft.com/office/drawing/2014/main" id="{CA9E9539-3E3D-01E6-B031-4725911AACA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36" y="3584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" name="Line 23">
              <a:extLst>
                <a:ext uri="{FF2B5EF4-FFF2-40B4-BE49-F238E27FC236}">
                  <a16:creationId xmlns:a16="http://schemas.microsoft.com/office/drawing/2014/main" id="{0D745B96-3B93-E109-D831-D5E6E9DD3A3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36" y="2971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" name="Line 24">
              <a:extLst>
                <a:ext uri="{FF2B5EF4-FFF2-40B4-BE49-F238E27FC236}">
                  <a16:creationId xmlns:a16="http://schemas.microsoft.com/office/drawing/2014/main" id="{DA5C0F03-779E-3C7F-D76F-87473411DE9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36" y="2352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" name="Line 25">
              <a:extLst>
                <a:ext uri="{FF2B5EF4-FFF2-40B4-BE49-F238E27FC236}">
                  <a16:creationId xmlns:a16="http://schemas.microsoft.com/office/drawing/2014/main" id="{234D57BB-1201-7DB1-0E43-E8DEAF5D059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36" y="1739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" name="Line 26">
              <a:extLst>
                <a:ext uri="{FF2B5EF4-FFF2-40B4-BE49-F238E27FC236}">
                  <a16:creationId xmlns:a16="http://schemas.microsoft.com/office/drawing/2014/main" id="{D5C1C8F8-5825-5718-6EC8-BDB2B7B8BC0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36" y="1120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" name="Line 27">
              <a:extLst>
                <a:ext uri="{FF2B5EF4-FFF2-40B4-BE49-F238E27FC236}">
                  <a16:creationId xmlns:a16="http://schemas.microsoft.com/office/drawing/2014/main" id="{62CBD7C0-1E59-2151-F409-14D488ECE49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36" y="502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" name="Rectangle 28">
              <a:extLst>
                <a:ext uri="{FF2B5EF4-FFF2-40B4-BE49-F238E27FC236}">
                  <a16:creationId xmlns:a16="http://schemas.microsoft.com/office/drawing/2014/main" id="{2DDEAC23-C16A-A214-380D-98236812D6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2" y="3548"/>
              <a:ext cx="166" cy="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0.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32" name="Rectangle 29">
              <a:extLst>
                <a:ext uri="{FF2B5EF4-FFF2-40B4-BE49-F238E27FC236}">
                  <a16:creationId xmlns:a16="http://schemas.microsoft.com/office/drawing/2014/main" id="{356457C0-62B6-667B-DB86-0D7698003F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2" y="2929"/>
              <a:ext cx="166" cy="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0.2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33" name="Rectangle 30">
              <a:extLst>
                <a:ext uri="{FF2B5EF4-FFF2-40B4-BE49-F238E27FC236}">
                  <a16:creationId xmlns:a16="http://schemas.microsoft.com/office/drawing/2014/main" id="{6FA223BB-DFFB-F5F0-2DB5-8C2AE7670C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2" y="2316"/>
              <a:ext cx="166" cy="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0.4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34" name="Rectangle 31">
              <a:extLst>
                <a:ext uri="{FF2B5EF4-FFF2-40B4-BE49-F238E27FC236}">
                  <a16:creationId xmlns:a16="http://schemas.microsoft.com/office/drawing/2014/main" id="{AD41AC84-4C2A-D153-938B-61EED26E09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2" y="1697"/>
              <a:ext cx="166" cy="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0.6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35" name="Rectangle 32">
              <a:extLst>
                <a:ext uri="{FF2B5EF4-FFF2-40B4-BE49-F238E27FC236}">
                  <a16:creationId xmlns:a16="http://schemas.microsoft.com/office/drawing/2014/main" id="{E4A1021D-6D7F-8D8A-3F9A-8BC22F8E35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2" y="1079"/>
              <a:ext cx="166" cy="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0.8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36" name="Rectangle 33">
              <a:extLst>
                <a:ext uri="{FF2B5EF4-FFF2-40B4-BE49-F238E27FC236}">
                  <a16:creationId xmlns:a16="http://schemas.microsoft.com/office/drawing/2014/main" id="{0C55629F-2AF0-5C86-8F76-6DA0454635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2" y="466"/>
              <a:ext cx="166" cy="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1.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37" name="Freeform 34">
              <a:extLst>
                <a:ext uri="{FF2B5EF4-FFF2-40B4-BE49-F238E27FC236}">
                  <a16:creationId xmlns:a16="http://schemas.microsoft.com/office/drawing/2014/main" id="{55E7D657-447D-6FC2-A169-9F9171DC2E0F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499" y="381"/>
              <a:ext cx="0" cy="3323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" name="Freeform 35">
              <a:extLst>
                <a:ext uri="{FF2B5EF4-FFF2-40B4-BE49-F238E27FC236}">
                  <a16:creationId xmlns:a16="http://schemas.microsoft.com/office/drawing/2014/main" id="{D2319F04-D822-2B08-45F3-FE98F606DA6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186" y="381"/>
              <a:ext cx="0" cy="3323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" name="Freeform 36">
              <a:extLst>
                <a:ext uri="{FF2B5EF4-FFF2-40B4-BE49-F238E27FC236}">
                  <a16:creationId xmlns:a16="http://schemas.microsoft.com/office/drawing/2014/main" id="{94590F4A-0E83-ABE5-610B-9EC9A3F46DF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880" y="381"/>
              <a:ext cx="0" cy="3323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" name="Freeform 37">
              <a:extLst>
                <a:ext uri="{FF2B5EF4-FFF2-40B4-BE49-F238E27FC236}">
                  <a16:creationId xmlns:a16="http://schemas.microsoft.com/office/drawing/2014/main" id="{339A888D-46E1-CFE2-779A-897A6F4B016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573" y="381"/>
              <a:ext cx="0" cy="3323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" name="Freeform 38">
              <a:extLst>
                <a:ext uri="{FF2B5EF4-FFF2-40B4-BE49-F238E27FC236}">
                  <a16:creationId xmlns:a16="http://schemas.microsoft.com/office/drawing/2014/main" id="{88AE232C-C7A2-3A31-C1F0-D41463ABAC2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261" y="381"/>
              <a:ext cx="0" cy="3323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" name="Freeform 39">
              <a:extLst>
                <a:ext uri="{FF2B5EF4-FFF2-40B4-BE49-F238E27FC236}">
                  <a16:creationId xmlns:a16="http://schemas.microsoft.com/office/drawing/2014/main" id="{01183D8B-1E8F-DC4F-82D3-FC455C8D1AC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954" y="381"/>
              <a:ext cx="0" cy="3323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" name="Freeform 40">
              <a:extLst>
                <a:ext uri="{FF2B5EF4-FFF2-40B4-BE49-F238E27FC236}">
                  <a16:creationId xmlns:a16="http://schemas.microsoft.com/office/drawing/2014/main" id="{232462AE-AAE8-5AB2-0FC8-A2AE9BB89D9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648" y="381"/>
              <a:ext cx="0" cy="3323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" name="Freeform 41">
              <a:extLst>
                <a:ext uri="{FF2B5EF4-FFF2-40B4-BE49-F238E27FC236}">
                  <a16:creationId xmlns:a16="http://schemas.microsoft.com/office/drawing/2014/main" id="{CF3FCC92-CBC6-E048-2689-81DCDD422A6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341" y="381"/>
              <a:ext cx="0" cy="3323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" name="Freeform 42">
              <a:extLst>
                <a:ext uri="{FF2B5EF4-FFF2-40B4-BE49-F238E27FC236}">
                  <a16:creationId xmlns:a16="http://schemas.microsoft.com/office/drawing/2014/main" id="{929F8C19-B544-4920-F11D-82E898A5176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029" y="381"/>
              <a:ext cx="0" cy="3323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" name="Freeform 43">
              <a:extLst>
                <a:ext uri="{FF2B5EF4-FFF2-40B4-BE49-F238E27FC236}">
                  <a16:creationId xmlns:a16="http://schemas.microsoft.com/office/drawing/2014/main" id="{3AA0C287-844B-F4DF-1B15-842DE955F0C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722" y="381"/>
              <a:ext cx="0" cy="3323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" name="Freeform 44">
              <a:extLst>
                <a:ext uri="{FF2B5EF4-FFF2-40B4-BE49-F238E27FC236}">
                  <a16:creationId xmlns:a16="http://schemas.microsoft.com/office/drawing/2014/main" id="{A879E2C3-4DEA-48A6-B6BD-FBB63A7DADF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416" y="381"/>
              <a:ext cx="0" cy="3323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" name="Freeform 45">
              <a:extLst>
                <a:ext uri="{FF2B5EF4-FFF2-40B4-BE49-F238E27FC236}">
                  <a16:creationId xmlns:a16="http://schemas.microsoft.com/office/drawing/2014/main" id="{BBEE2F1E-456E-8136-224B-A76546BD029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296" y="3584"/>
              <a:ext cx="3323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" name="Freeform 46">
              <a:extLst>
                <a:ext uri="{FF2B5EF4-FFF2-40B4-BE49-F238E27FC236}">
                  <a16:creationId xmlns:a16="http://schemas.microsoft.com/office/drawing/2014/main" id="{11606E23-940B-F84B-CD53-F1F98F90F3D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296" y="3278"/>
              <a:ext cx="3323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" name="Freeform 47">
              <a:extLst>
                <a:ext uri="{FF2B5EF4-FFF2-40B4-BE49-F238E27FC236}">
                  <a16:creationId xmlns:a16="http://schemas.microsoft.com/office/drawing/2014/main" id="{F2E9FB85-BF30-7D6B-C74A-38F93649CA4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296" y="2971"/>
              <a:ext cx="3323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" name="Freeform 48">
              <a:extLst>
                <a:ext uri="{FF2B5EF4-FFF2-40B4-BE49-F238E27FC236}">
                  <a16:creationId xmlns:a16="http://schemas.microsoft.com/office/drawing/2014/main" id="{82219192-FF4B-BC00-81AC-637180A50C2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296" y="2659"/>
              <a:ext cx="3323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" name="Freeform 49">
              <a:extLst>
                <a:ext uri="{FF2B5EF4-FFF2-40B4-BE49-F238E27FC236}">
                  <a16:creationId xmlns:a16="http://schemas.microsoft.com/office/drawing/2014/main" id="{F10855FF-EA03-1949-6822-DD3F10EBD2A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296" y="2352"/>
              <a:ext cx="3323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" name="Freeform 50">
              <a:extLst>
                <a:ext uri="{FF2B5EF4-FFF2-40B4-BE49-F238E27FC236}">
                  <a16:creationId xmlns:a16="http://schemas.microsoft.com/office/drawing/2014/main" id="{865F3E33-C6D5-6CD1-37D6-DE664E48388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296" y="2046"/>
              <a:ext cx="3323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" name="Freeform 51">
              <a:extLst>
                <a:ext uri="{FF2B5EF4-FFF2-40B4-BE49-F238E27FC236}">
                  <a16:creationId xmlns:a16="http://schemas.microsoft.com/office/drawing/2014/main" id="{12D06D8B-619A-FF8A-7834-E8AC8CF00FD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296" y="1739"/>
              <a:ext cx="3323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" name="Freeform 52">
              <a:extLst>
                <a:ext uri="{FF2B5EF4-FFF2-40B4-BE49-F238E27FC236}">
                  <a16:creationId xmlns:a16="http://schemas.microsoft.com/office/drawing/2014/main" id="{102AE838-266A-1467-20D9-CE88120F0ED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296" y="1427"/>
              <a:ext cx="3323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" name="Freeform 53">
              <a:extLst>
                <a:ext uri="{FF2B5EF4-FFF2-40B4-BE49-F238E27FC236}">
                  <a16:creationId xmlns:a16="http://schemas.microsoft.com/office/drawing/2014/main" id="{E9D094AA-CA96-8CDF-1B84-DE18DB101D7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296" y="1120"/>
              <a:ext cx="3323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" name="Freeform 54">
              <a:extLst>
                <a:ext uri="{FF2B5EF4-FFF2-40B4-BE49-F238E27FC236}">
                  <a16:creationId xmlns:a16="http://schemas.microsoft.com/office/drawing/2014/main" id="{DEC6F755-DF58-6154-CB6C-C3560D9BB34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296" y="814"/>
              <a:ext cx="3323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" name="Freeform 55">
              <a:extLst>
                <a:ext uri="{FF2B5EF4-FFF2-40B4-BE49-F238E27FC236}">
                  <a16:creationId xmlns:a16="http://schemas.microsoft.com/office/drawing/2014/main" id="{290BF418-28F7-4F89-8A11-385AE4460E3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296" y="502"/>
              <a:ext cx="3323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9525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" name="Line 56">
              <a:extLst>
                <a:ext uri="{FF2B5EF4-FFF2-40B4-BE49-F238E27FC236}">
                  <a16:creationId xmlns:a16="http://schemas.microsoft.com/office/drawing/2014/main" id="{26D11CC0-BE61-7A74-496C-5779287E855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90" y="381"/>
              <a:ext cx="3329" cy="3329"/>
            </a:xfrm>
            <a:prstGeom prst="line">
              <a:avLst/>
            </a:prstGeom>
            <a:noFill/>
            <a:ln w="9525" cap="rnd">
              <a:solidFill>
                <a:srgbClr val="A9A9A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0" name="Freeform 57">
              <a:extLst>
                <a:ext uri="{FF2B5EF4-FFF2-40B4-BE49-F238E27FC236}">
                  <a16:creationId xmlns:a16="http://schemas.microsoft.com/office/drawing/2014/main" id="{4AB60907-1CDF-DBF0-DC3F-9B1109A825FD}"/>
                </a:ext>
              </a:extLst>
            </p:cNvPr>
            <p:cNvSpPr>
              <a:spLocks/>
            </p:cNvSpPr>
            <p:nvPr/>
          </p:nvSpPr>
          <p:spPr bwMode="auto">
            <a:xfrm>
              <a:off x="2416" y="502"/>
              <a:ext cx="3083" cy="3082"/>
            </a:xfrm>
            <a:custGeom>
              <a:avLst/>
              <a:gdLst>
                <a:gd name="T0" fmla="*/ 502 w 513"/>
                <a:gd name="T1" fmla="*/ 0 h 513"/>
                <a:gd name="T2" fmla="*/ 492 w 513"/>
                <a:gd name="T3" fmla="*/ 11 h 513"/>
                <a:gd name="T4" fmla="*/ 471 w 513"/>
                <a:gd name="T5" fmla="*/ 11 h 513"/>
                <a:gd name="T6" fmla="*/ 460 w 513"/>
                <a:gd name="T7" fmla="*/ 22 h 513"/>
                <a:gd name="T8" fmla="*/ 450 w 513"/>
                <a:gd name="T9" fmla="*/ 33 h 513"/>
                <a:gd name="T10" fmla="*/ 429 w 513"/>
                <a:gd name="T11" fmla="*/ 33 h 513"/>
                <a:gd name="T12" fmla="*/ 429 w 513"/>
                <a:gd name="T13" fmla="*/ 55 h 513"/>
                <a:gd name="T14" fmla="*/ 418 w 513"/>
                <a:gd name="T15" fmla="*/ 66 h 513"/>
                <a:gd name="T16" fmla="*/ 398 w 513"/>
                <a:gd name="T17" fmla="*/ 66 h 513"/>
                <a:gd name="T18" fmla="*/ 377 w 513"/>
                <a:gd name="T19" fmla="*/ 66 h 513"/>
                <a:gd name="T20" fmla="*/ 377 w 513"/>
                <a:gd name="T21" fmla="*/ 88 h 513"/>
                <a:gd name="T22" fmla="*/ 366 w 513"/>
                <a:gd name="T23" fmla="*/ 99 h 513"/>
                <a:gd name="T24" fmla="*/ 356 w 513"/>
                <a:gd name="T25" fmla="*/ 109 h 513"/>
                <a:gd name="T26" fmla="*/ 335 w 513"/>
                <a:gd name="T27" fmla="*/ 109 h 513"/>
                <a:gd name="T28" fmla="*/ 324 w 513"/>
                <a:gd name="T29" fmla="*/ 120 h 513"/>
                <a:gd name="T30" fmla="*/ 314 w 513"/>
                <a:gd name="T31" fmla="*/ 131 h 513"/>
                <a:gd name="T32" fmla="*/ 293 w 513"/>
                <a:gd name="T33" fmla="*/ 131 h 513"/>
                <a:gd name="T34" fmla="*/ 272 w 513"/>
                <a:gd name="T35" fmla="*/ 131 h 513"/>
                <a:gd name="T36" fmla="*/ 272 w 513"/>
                <a:gd name="T37" fmla="*/ 153 h 513"/>
                <a:gd name="T38" fmla="*/ 261 w 513"/>
                <a:gd name="T39" fmla="*/ 164 h 513"/>
                <a:gd name="T40" fmla="*/ 251 w 513"/>
                <a:gd name="T41" fmla="*/ 175 h 513"/>
                <a:gd name="T42" fmla="*/ 240 w 513"/>
                <a:gd name="T43" fmla="*/ 186 h 513"/>
                <a:gd name="T44" fmla="*/ 230 w 513"/>
                <a:gd name="T45" fmla="*/ 197 h 513"/>
                <a:gd name="T46" fmla="*/ 209 w 513"/>
                <a:gd name="T47" fmla="*/ 197 h 513"/>
                <a:gd name="T48" fmla="*/ 188 w 513"/>
                <a:gd name="T49" fmla="*/ 197 h 513"/>
                <a:gd name="T50" fmla="*/ 178 w 513"/>
                <a:gd name="T51" fmla="*/ 208 h 513"/>
                <a:gd name="T52" fmla="*/ 178 w 513"/>
                <a:gd name="T53" fmla="*/ 230 h 513"/>
                <a:gd name="T54" fmla="*/ 157 w 513"/>
                <a:gd name="T55" fmla="*/ 230 h 513"/>
                <a:gd name="T56" fmla="*/ 146 w 513"/>
                <a:gd name="T57" fmla="*/ 240 h 513"/>
                <a:gd name="T58" fmla="*/ 146 w 513"/>
                <a:gd name="T59" fmla="*/ 262 h 513"/>
                <a:gd name="T60" fmla="*/ 136 w 513"/>
                <a:gd name="T61" fmla="*/ 273 h 513"/>
                <a:gd name="T62" fmla="*/ 136 w 513"/>
                <a:gd name="T63" fmla="*/ 295 h 513"/>
                <a:gd name="T64" fmla="*/ 125 w 513"/>
                <a:gd name="T65" fmla="*/ 306 h 513"/>
                <a:gd name="T66" fmla="*/ 125 w 513"/>
                <a:gd name="T67" fmla="*/ 328 h 513"/>
                <a:gd name="T68" fmla="*/ 115 w 513"/>
                <a:gd name="T69" fmla="*/ 339 h 513"/>
                <a:gd name="T70" fmla="*/ 94 w 513"/>
                <a:gd name="T71" fmla="*/ 339 h 513"/>
                <a:gd name="T72" fmla="*/ 94 w 513"/>
                <a:gd name="T73" fmla="*/ 360 h 513"/>
                <a:gd name="T74" fmla="*/ 94 w 513"/>
                <a:gd name="T75" fmla="*/ 382 h 513"/>
                <a:gd name="T76" fmla="*/ 94 w 513"/>
                <a:gd name="T77" fmla="*/ 404 h 513"/>
                <a:gd name="T78" fmla="*/ 73 w 513"/>
                <a:gd name="T79" fmla="*/ 404 h 513"/>
                <a:gd name="T80" fmla="*/ 73 w 513"/>
                <a:gd name="T81" fmla="*/ 426 h 513"/>
                <a:gd name="T82" fmla="*/ 63 w 513"/>
                <a:gd name="T83" fmla="*/ 437 h 513"/>
                <a:gd name="T84" fmla="*/ 63 w 513"/>
                <a:gd name="T85" fmla="*/ 459 h 513"/>
                <a:gd name="T86" fmla="*/ 63 w 513"/>
                <a:gd name="T87" fmla="*/ 481 h 513"/>
                <a:gd name="T88" fmla="*/ 42 w 513"/>
                <a:gd name="T89" fmla="*/ 481 h 513"/>
                <a:gd name="T90" fmla="*/ 31 w 513"/>
                <a:gd name="T91" fmla="*/ 491 h 513"/>
                <a:gd name="T92" fmla="*/ 21 w 513"/>
                <a:gd name="T93" fmla="*/ 502 h 513"/>
                <a:gd name="T94" fmla="*/ 10 w 513"/>
                <a:gd name="T95" fmla="*/ 513 h 5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</a:cxnLst>
              <a:rect l="0" t="0" r="r" b="b"/>
              <a:pathLst>
                <a:path w="513" h="513">
                  <a:moveTo>
                    <a:pt x="513" y="0"/>
                  </a:moveTo>
                  <a:lnTo>
                    <a:pt x="502" y="0"/>
                  </a:lnTo>
                  <a:lnTo>
                    <a:pt x="502" y="11"/>
                  </a:lnTo>
                  <a:lnTo>
                    <a:pt x="492" y="11"/>
                  </a:lnTo>
                  <a:lnTo>
                    <a:pt x="481" y="11"/>
                  </a:lnTo>
                  <a:lnTo>
                    <a:pt x="471" y="11"/>
                  </a:lnTo>
                  <a:lnTo>
                    <a:pt x="471" y="22"/>
                  </a:lnTo>
                  <a:lnTo>
                    <a:pt x="460" y="22"/>
                  </a:lnTo>
                  <a:lnTo>
                    <a:pt x="460" y="33"/>
                  </a:lnTo>
                  <a:lnTo>
                    <a:pt x="450" y="33"/>
                  </a:lnTo>
                  <a:lnTo>
                    <a:pt x="439" y="33"/>
                  </a:lnTo>
                  <a:lnTo>
                    <a:pt x="429" y="33"/>
                  </a:lnTo>
                  <a:lnTo>
                    <a:pt x="429" y="44"/>
                  </a:lnTo>
                  <a:lnTo>
                    <a:pt x="429" y="55"/>
                  </a:lnTo>
                  <a:lnTo>
                    <a:pt x="429" y="66"/>
                  </a:lnTo>
                  <a:lnTo>
                    <a:pt x="418" y="66"/>
                  </a:lnTo>
                  <a:lnTo>
                    <a:pt x="408" y="66"/>
                  </a:lnTo>
                  <a:lnTo>
                    <a:pt x="398" y="66"/>
                  </a:lnTo>
                  <a:lnTo>
                    <a:pt x="387" y="66"/>
                  </a:lnTo>
                  <a:lnTo>
                    <a:pt x="377" y="66"/>
                  </a:lnTo>
                  <a:lnTo>
                    <a:pt x="377" y="77"/>
                  </a:lnTo>
                  <a:lnTo>
                    <a:pt x="377" y="88"/>
                  </a:lnTo>
                  <a:lnTo>
                    <a:pt x="377" y="99"/>
                  </a:lnTo>
                  <a:lnTo>
                    <a:pt x="366" y="99"/>
                  </a:lnTo>
                  <a:lnTo>
                    <a:pt x="356" y="99"/>
                  </a:lnTo>
                  <a:lnTo>
                    <a:pt x="356" y="109"/>
                  </a:lnTo>
                  <a:lnTo>
                    <a:pt x="345" y="109"/>
                  </a:lnTo>
                  <a:lnTo>
                    <a:pt x="335" y="109"/>
                  </a:lnTo>
                  <a:lnTo>
                    <a:pt x="335" y="120"/>
                  </a:lnTo>
                  <a:lnTo>
                    <a:pt x="324" y="120"/>
                  </a:lnTo>
                  <a:lnTo>
                    <a:pt x="314" y="120"/>
                  </a:lnTo>
                  <a:lnTo>
                    <a:pt x="314" y="131"/>
                  </a:lnTo>
                  <a:lnTo>
                    <a:pt x="303" y="131"/>
                  </a:lnTo>
                  <a:lnTo>
                    <a:pt x="293" y="131"/>
                  </a:lnTo>
                  <a:lnTo>
                    <a:pt x="282" y="131"/>
                  </a:lnTo>
                  <a:lnTo>
                    <a:pt x="272" y="131"/>
                  </a:lnTo>
                  <a:lnTo>
                    <a:pt x="272" y="142"/>
                  </a:lnTo>
                  <a:lnTo>
                    <a:pt x="272" y="153"/>
                  </a:lnTo>
                  <a:lnTo>
                    <a:pt x="261" y="153"/>
                  </a:lnTo>
                  <a:lnTo>
                    <a:pt x="261" y="164"/>
                  </a:lnTo>
                  <a:lnTo>
                    <a:pt x="251" y="164"/>
                  </a:lnTo>
                  <a:lnTo>
                    <a:pt x="251" y="175"/>
                  </a:lnTo>
                  <a:lnTo>
                    <a:pt x="240" y="175"/>
                  </a:lnTo>
                  <a:lnTo>
                    <a:pt x="240" y="186"/>
                  </a:lnTo>
                  <a:lnTo>
                    <a:pt x="230" y="186"/>
                  </a:lnTo>
                  <a:lnTo>
                    <a:pt x="230" y="197"/>
                  </a:lnTo>
                  <a:lnTo>
                    <a:pt x="220" y="197"/>
                  </a:lnTo>
                  <a:lnTo>
                    <a:pt x="209" y="197"/>
                  </a:lnTo>
                  <a:lnTo>
                    <a:pt x="199" y="197"/>
                  </a:lnTo>
                  <a:lnTo>
                    <a:pt x="188" y="197"/>
                  </a:lnTo>
                  <a:lnTo>
                    <a:pt x="188" y="208"/>
                  </a:lnTo>
                  <a:lnTo>
                    <a:pt x="178" y="208"/>
                  </a:lnTo>
                  <a:lnTo>
                    <a:pt x="178" y="219"/>
                  </a:lnTo>
                  <a:lnTo>
                    <a:pt x="178" y="230"/>
                  </a:lnTo>
                  <a:lnTo>
                    <a:pt x="167" y="230"/>
                  </a:lnTo>
                  <a:lnTo>
                    <a:pt x="157" y="230"/>
                  </a:lnTo>
                  <a:lnTo>
                    <a:pt x="157" y="240"/>
                  </a:lnTo>
                  <a:lnTo>
                    <a:pt x="146" y="240"/>
                  </a:lnTo>
                  <a:lnTo>
                    <a:pt x="146" y="251"/>
                  </a:lnTo>
                  <a:lnTo>
                    <a:pt x="146" y="262"/>
                  </a:lnTo>
                  <a:lnTo>
                    <a:pt x="146" y="273"/>
                  </a:lnTo>
                  <a:lnTo>
                    <a:pt x="136" y="273"/>
                  </a:lnTo>
                  <a:lnTo>
                    <a:pt x="136" y="284"/>
                  </a:lnTo>
                  <a:lnTo>
                    <a:pt x="136" y="295"/>
                  </a:lnTo>
                  <a:lnTo>
                    <a:pt x="136" y="306"/>
                  </a:lnTo>
                  <a:lnTo>
                    <a:pt x="125" y="306"/>
                  </a:lnTo>
                  <a:lnTo>
                    <a:pt x="125" y="317"/>
                  </a:lnTo>
                  <a:lnTo>
                    <a:pt x="125" y="328"/>
                  </a:lnTo>
                  <a:lnTo>
                    <a:pt x="115" y="328"/>
                  </a:lnTo>
                  <a:lnTo>
                    <a:pt x="115" y="339"/>
                  </a:lnTo>
                  <a:lnTo>
                    <a:pt x="104" y="339"/>
                  </a:lnTo>
                  <a:lnTo>
                    <a:pt x="94" y="339"/>
                  </a:lnTo>
                  <a:lnTo>
                    <a:pt x="94" y="350"/>
                  </a:lnTo>
                  <a:lnTo>
                    <a:pt x="94" y="360"/>
                  </a:lnTo>
                  <a:lnTo>
                    <a:pt x="94" y="371"/>
                  </a:lnTo>
                  <a:lnTo>
                    <a:pt x="94" y="382"/>
                  </a:lnTo>
                  <a:lnTo>
                    <a:pt x="94" y="393"/>
                  </a:lnTo>
                  <a:lnTo>
                    <a:pt x="94" y="404"/>
                  </a:lnTo>
                  <a:lnTo>
                    <a:pt x="83" y="404"/>
                  </a:lnTo>
                  <a:lnTo>
                    <a:pt x="73" y="404"/>
                  </a:lnTo>
                  <a:lnTo>
                    <a:pt x="73" y="415"/>
                  </a:lnTo>
                  <a:lnTo>
                    <a:pt x="73" y="426"/>
                  </a:lnTo>
                  <a:lnTo>
                    <a:pt x="73" y="437"/>
                  </a:lnTo>
                  <a:lnTo>
                    <a:pt x="63" y="437"/>
                  </a:lnTo>
                  <a:lnTo>
                    <a:pt x="63" y="448"/>
                  </a:lnTo>
                  <a:lnTo>
                    <a:pt x="63" y="459"/>
                  </a:lnTo>
                  <a:lnTo>
                    <a:pt x="63" y="470"/>
                  </a:lnTo>
                  <a:lnTo>
                    <a:pt x="63" y="481"/>
                  </a:lnTo>
                  <a:lnTo>
                    <a:pt x="52" y="481"/>
                  </a:lnTo>
                  <a:lnTo>
                    <a:pt x="42" y="481"/>
                  </a:lnTo>
                  <a:lnTo>
                    <a:pt x="42" y="491"/>
                  </a:lnTo>
                  <a:lnTo>
                    <a:pt x="31" y="491"/>
                  </a:lnTo>
                  <a:lnTo>
                    <a:pt x="31" y="502"/>
                  </a:lnTo>
                  <a:lnTo>
                    <a:pt x="21" y="502"/>
                  </a:lnTo>
                  <a:lnTo>
                    <a:pt x="10" y="502"/>
                  </a:lnTo>
                  <a:lnTo>
                    <a:pt x="10" y="513"/>
                  </a:lnTo>
                  <a:lnTo>
                    <a:pt x="0" y="513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1" name="Rectangle 58">
              <a:extLst>
                <a:ext uri="{FF2B5EF4-FFF2-40B4-BE49-F238E27FC236}">
                  <a16:creationId xmlns:a16="http://schemas.microsoft.com/office/drawing/2014/main" id="{3A06DDDF-85CC-1041-35F1-E94C8D609A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40" y="1673"/>
              <a:ext cx="18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" name="Rectangle 59">
              <a:extLst>
                <a:ext uri="{FF2B5EF4-FFF2-40B4-BE49-F238E27FC236}">
                  <a16:creationId xmlns:a16="http://schemas.microsoft.com/office/drawing/2014/main" id="{0EC11105-AF4C-2C76-E3BA-C60E493E87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40" y="1697"/>
              <a:ext cx="18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3" name="Rectangle 60">
              <a:extLst>
                <a:ext uri="{FF2B5EF4-FFF2-40B4-BE49-F238E27FC236}">
                  <a16:creationId xmlns:a16="http://schemas.microsoft.com/office/drawing/2014/main" id="{DB4F492E-1EF1-2DF9-816F-86C7796648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34" y="1679"/>
              <a:ext cx="30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4" name="Rectangle 61">
              <a:extLst>
                <a:ext uri="{FF2B5EF4-FFF2-40B4-BE49-F238E27FC236}">
                  <a16:creationId xmlns:a16="http://schemas.microsoft.com/office/drawing/2014/main" id="{9BE1B9C0-F01B-D9D6-E527-4D33959751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34" y="1691"/>
              <a:ext cx="30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5" name="Rectangle 62">
              <a:extLst>
                <a:ext uri="{FF2B5EF4-FFF2-40B4-BE49-F238E27FC236}">
                  <a16:creationId xmlns:a16="http://schemas.microsoft.com/office/drawing/2014/main" id="{FD9589B8-9A95-27F3-1F22-BD3BE97866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34" y="1685"/>
              <a:ext cx="30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" name="Rectangle 63">
              <a:extLst>
                <a:ext uri="{FF2B5EF4-FFF2-40B4-BE49-F238E27FC236}">
                  <a16:creationId xmlns:a16="http://schemas.microsoft.com/office/drawing/2014/main" id="{C381D66F-C81D-2E93-4E57-5F69DAD016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34" y="1685"/>
              <a:ext cx="30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7" name="Oval 64">
              <a:extLst>
                <a:ext uri="{FF2B5EF4-FFF2-40B4-BE49-F238E27FC236}">
                  <a16:creationId xmlns:a16="http://schemas.microsoft.com/office/drawing/2014/main" id="{AB7950EA-303E-37E8-DA8B-C6D8A66D0B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34" y="1673"/>
              <a:ext cx="24" cy="24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8" name="Rectangle 65">
              <a:extLst>
                <a:ext uri="{FF2B5EF4-FFF2-40B4-BE49-F238E27FC236}">
                  <a16:creationId xmlns:a16="http://schemas.microsoft.com/office/drawing/2014/main" id="{7A16E9D8-156C-8ECB-BF75-DDEA48C1A0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88" y="1703"/>
              <a:ext cx="1445" cy="1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6.601 (0.633, 0.617)</a:t>
              </a:r>
              <a:endParaRPr kumimoji="0" lang="ja-JP" altLang="ja-JP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</p:grp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4D7D17FB-0113-4C5C-1E5A-89DA96470538}"/>
              </a:ext>
            </a:extLst>
          </p:cNvPr>
          <p:cNvSpPr txBox="1"/>
          <p:nvPr/>
        </p:nvSpPr>
        <p:spPr>
          <a:xfrm>
            <a:off x="4688608" y="4926370"/>
            <a:ext cx="398004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メイリオ" panose="020B0604030504040204" pitchFamily="50" charset="-128"/>
                <a:ea typeface="メイリオ" panose="020B0604030504040204" pitchFamily="50" charset="-128"/>
                <a:cs typeface="Times New Roman" panose="02020603050405020304" pitchFamily="18" charset="0"/>
              </a:rPr>
              <a:t>Area under the curve 0.61 (95%</a:t>
            </a:r>
            <a:r>
              <a:rPr lang="en-US" altLang="ja-JP" sz="1600" dirty="0">
                <a:latin typeface="メイリオ" panose="020B0604030504040204" pitchFamily="50" charset="-128"/>
                <a:ea typeface="メイリオ" panose="020B0604030504040204" pitchFamily="50" charset="-128"/>
                <a:cs typeface="Times New Roman" panose="02020603050405020304" pitchFamily="18" charset="0"/>
              </a:rPr>
              <a:t>Confidential</a:t>
            </a:r>
            <a:r>
              <a:rPr lang="ja-JP" altLang="en-US" sz="1600" dirty="0">
                <a:latin typeface="メイリオ" panose="020B0604030504040204" pitchFamily="50" charset="-128"/>
                <a:ea typeface="メイリオ" panose="020B0604030504040204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メイリオ" panose="020B0604030504040204" pitchFamily="50" charset="-128"/>
                <a:ea typeface="メイリオ" panose="020B0604030504040204" pitchFamily="50" charset="-128"/>
                <a:cs typeface="Times New Roman" panose="02020603050405020304" pitchFamily="18" charset="0"/>
              </a:rPr>
              <a:t>interval:</a:t>
            </a:r>
            <a:r>
              <a:rPr kumimoji="1" lang="ja-JP" altLang="en-US" sz="1600" dirty="0">
                <a:latin typeface="メイリオ" panose="020B0604030504040204" pitchFamily="50" charset="-128"/>
                <a:ea typeface="メイリオ" panose="020B0604030504040204" pitchFamily="50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1600" dirty="0">
                <a:latin typeface="メイリオ" panose="020B0604030504040204" pitchFamily="50" charset="-128"/>
                <a:ea typeface="メイリオ" panose="020B0604030504040204" pitchFamily="50" charset="-128"/>
                <a:cs typeface="Times New Roman" panose="02020603050405020304" pitchFamily="18" charset="0"/>
              </a:rPr>
              <a:t>0.49-0.72)</a:t>
            </a:r>
            <a:endParaRPr kumimoji="1" lang="ja-JP" altLang="en-US" sz="1600" dirty="0">
              <a:latin typeface="メイリオ" panose="020B0604030504040204" pitchFamily="50" charset="-128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F7CF035-E858-BCB0-4309-0A56BF4244DB}"/>
              </a:ext>
            </a:extLst>
          </p:cNvPr>
          <p:cNvSpPr txBox="1"/>
          <p:nvPr/>
        </p:nvSpPr>
        <p:spPr>
          <a:xfrm>
            <a:off x="457201" y="6047714"/>
            <a:ext cx="11277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S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</a:rPr>
              <a:t>1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: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</a:rPr>
              <a:t>The ROC curve analysis for cut-off values of muscle loss rate.</a:t>
            </a:r>
          </a:p>
          <a:p>
            <a:r>
              <a:rPr lang="en-US" sz="1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</a:rPr>
              <a:t>Muscle loss rate was categorized according to the cut-off values determined by ROC analysis, and the cut-off is 6.6%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499670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81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メイリオ</vt:lpstr>
      <vt:lpstr>游ゴシック</vt:lpstr>
      <vt:lpstr>游ゴシック Light</vt:lpstr>
      <vt:lpstr>Arial</vt:lpstr>
      <vt:lpstr>Times New Roman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直哉 西岡</dc:creator>
  <cp:lastModifiedBy>MDPI</cp:lastModifiedBy>
  <cp:revision>3</cp:revision>
  <dcterms:created xsi:type="dcterms:W3CDTF">2024-08-26T18:23:22Z</dcterms:created>
  <dcterms:modified xsi:type="dcterms:W3CDTF">2024-08-30T13:48:01Z</dcterms:modified>
</cp:coreProperties>
</file>